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6B9667-73C6-4100-A13C-DD6D2153C3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6F993-E5FE-43FB-BACC-C9CB49F5FC9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80E0DD-97A2-4309-AAE5-01AF0081895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D13FF4-38DD-477A-8788-24FEB88962A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7E3EA-7FDA-4C76-A1D4-D1C4D26A57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549E8-FFCC-4026-8AAF-CCC7C519C2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9A77AB-DEAA-4938-BCA5-A685920881B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1D2C7-67B4-4F03-91BF-B26E153E4B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5CB2D3-3A42-46A3-A233-282E15FBF6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DEF90-4886-49C1-83AF-81913D6500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09CAB8-453D-437A-A8C2-4948830108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D88C0-7507-4398-95F0-FA9AAC35E2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96F809-C62B-4D8B-8AED-5BFE41CE027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990720" y="190512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5"/>
          <p:cNvSpPr/>
          <p:nvPr/>
        </p:nvSpPr>
        <p:spPr>
          <a:xfrm>
            <a:off x="457200" y="1447920"/>
            <a:ext cx="5943600" cy="466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TCTAAAAACCAGCAGAGGAAGCACAGGATTTTGCACTGACTGGTCAGGAGTAGGAAAGATCAAGAGACGAGACAGAAGCTTTATGAGCACAGGTCTGCTCAGGTGTTGGAGTT</a:t>
            </a:r>
            <a:r>
              <a:rPr b="1" lang="en-US" sz="1000" spc="-1" strike="noStrike" u="sng">
                <a:solidFill>
                  <a:srgbClr val="0d0d0d"/>
                </a:solidFill>
                <a:uFillTx/>
                <a:latin typeface="Courier New"/>
                <a:ea typeface="Courier New"/>
              </a:rPr>
              <a:t>ATG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AATGGGATGCTGCCCCTGCACACACTCACCACCGGCCAAACGGTGGTTAACACTGTGAATGAAGTCACCGTCCTTCTGCTCTTACTACTGCTGCTGCTGCTCTTCACCACCTGGAGCCGAACAAACCGTTCAAATATACCAGGTCCTTCCTTCTGGGCAGGACTCGGTCCTATCCTCACATACACCAGATTCATCTGGACTGGGATCGGAACGGCATGCAACTACTATAACAACAAGTATGGCAGCATAGTCCGGGTCTGGATTAAAGGTGAAGAGACCATCATTCTGAGCAGGTCCTCAGCAGTGTATCATGTTCTGAGGAGTGACCACTACACAGCCAGATTTGGGAGTAAAGCAGGGTTGGAGTGTATTGGGATGGAAGGGAGGGGTATTATTTTCAACAGTGATGTCCCACTCTGGAAAAAAACAAGGACGTATTTTTCCAAAGCTCTGACAGGCCCCGGCCTCCAGAGGACTGTGGGAATCTGTGTGCACTCCACAGCCAAACACCTGGACTGCCTGCAGGAGATGACTGACCCCTCCGGACATGTGGACTCGCTCAATCTGCTGAGAGCCATAGTGGTGGACATTTCCAACAGGCTTTTCCTCAGGGTGCCACTCAATGAAAAGGACTTGCTGATGAAAATCCAAAGCTATTTTGAGACCTGGCAAACTGTTTTAATAAAGCCTGATATATTCTTCAAGATTGGATGGCTGTACAACAAGCACAAGAAAGCAGCCCAGGAGCTGCAAGACATGATGGAGAGCCTTATTGAAATTAAAAGAAAGATTATAAATGAGTCTGAGAAGCTGGATGATGATCTTGACTTTGCAACAGAGCTCATATTTGCTCAGAACGTCGGCGAGCTTTCGGCGGATAACGTCAGGCAGTGCGTGCTGGAGATGGTGATCGCAGCGCCTGACACCCTTTCCATCAGCCTCTTCTTCATGCTGATGCTGCTGAAACAAAACCCAGACGTAGAGTTGAGGATAGTGGAGGAGATGGACGCTGTCTTGAGTGAGAAAGGCGGTGAAAGCATCAATTATCAAAGCTTGAAAGTGCTGGAGAGTTTCATCAATGAGTCTATGAGGTTTCATCCTGTGGTTGATTTCACAATGAGGAAAGCTCTGGAGGATGACATCATCGAGGGCACTAAAATTACAAAAGGCACCAACATCATTCTCAACATTGGTCTCATGCATAAATCAGAATTTTTCCCAAAACCCAAAGAGTTCAGCCTGACCAACTTTGACAAAACAGTTCCCAGTCGTTTCTTCCAGCCCTTCGGCTGTGGGCCTCGTTCCTGCGTGGGAAAACACATCGCCATGGTGATGATGAAGGCCATCCTGGTCACTCTGTTGTCTCGTTACACTGTGTGCCCTCGCCAAGGCTGCACCCTCAACAGCATCAGGCAGACCAACAACCTGTCGCAGCAGCCCGTGGAGGACGAGCACAGCCTGGCCATGCGCTTCATCCCTCGGACGCCACCGCACAGTCAGCAC</a:t>
            </a:r>
            <a:r>
              <a:rPr b="1" lang="en-US" sz="1000" spc="-1" strike="noStrike" u="sng">
                <a:solidFill>
                  <a:srgbClr val="000000"/>
                </a:solidFill>
                <a:uFillTx/>
                <a:latin typeface="Courier New"/>
                <a:ea typeface="Courier New"/>
              </a:rPr>
              <a:t>TGA</a:t>
            </a:r>
            <a:r>
              <a:rPr b="0" lang="en-US" sz="1000" spc="-1" strike="noStrike">
                <a:solidFill>
                  <a:srgbClr val="000000"/>
                </a:solidFill>
                <a:latin typeface="Courier New"/>
                <a:ea typeface="Courier New"/>
              </a:rPr>
              <a:t>GACACTCGGTGCAATCCTAAGTGTTGAATATGGTGAAGAATGTAGCTGGTGAATAGGATCTAATATCCCCTCACTAAAATTATACAAATGTGACCCATGACCTCTGGTATTCTGGGTTTTCATAGTGTATTTCTGAGTCTGCTTCAAAGAGCAAACAAACATTAAATTTATTACGTCGCAGCGGATGTTTTGCCTACTTTGACATCACTGACATGTTTAATACTGTTGATATTTTACATACAGTTCTGTTTCTTTAGGGATTATTGTGTTAAACATTATCAGTGTTATCAGTCATATGGTAAAGGAAGTAGTGTTATGTGTTAAGTGTTGTTAGTGTTAGACATAAACCTCATGTTAAAATTTCAGCACCACACTGGAAATGTGAAATATTAGTATGCTGTAAATCCAATTATCCTTTCTATCACATATATATTAAATCTCTAGATAAAAGGTAATGTTAAGGTAAAAAGTTTAAGGTTTCTTTTTAAAGTCTCAGTGAAAGGAAACGATGACTTTGTGACATAGGCATTAAATGAAATGTTACTAATATTTTGTGGTGTTTGCTCAAAGTAAATTCTCATTCAAAAAAAAAAAAAAAAAAA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1"/>
          <p:cNvSpPr/>
          <p:nvPr/>
        </p:nvSpPr>
        <p:spPr>
          <a:xfrm>
            <a:off x="2617560" y="838080"/>
            <a:ext cx="1622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2"/>
          <p:cNvSpPr/>
          <p:nvPr/>
        </p:nvSpPr>
        <p:spPr>
          <a:xfrm>
            <a:off x="419040" y="6259680"/>
            <a:ext cx="598176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lementary Figure 2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Full-length nucleotide sequence of Atlantic croaker </a:t>
            </a:r>
            <a:r>
              <a:rPr b="0" i="1" lang="en-US" sz="1000" spc="-1" strike="noStrike">
                <a:solidFill>
                  <a:srgbClr val="0d0d0d"/>
                </a:solidFill>
                <a:latin typeface="Arial"/>
                <a:ea typeface="MS Mincho"/>
              </a:rPr>
              <a:t>Micropogonias undulatus </a:t>
            </a:r>
            <a:r>
              <a:rPr b="0" lang="en-US" sz="1000" spc="-1" strike="noStrike">
                <a:solidFill>
                  <a:srgbClr val="0d0d0d"/>
                </a:solidFill>
                <a:latin typeface="Arial"/>
                <a:ea typeface="MS Mincho"/>
              </a:rPr>
              <a:t>brain cytochrome P450 aromatase cDNA. A stop and start codons are underlined. The nucleotide sequence data and predicted amino acid sequence (Fig. 1) can be found in the GenBank database (Accession no. JF300170)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7-17T19:42:46Z</dcterms:created>
  <dc:creator>Rahmon Sayed</dc:creator>
  <dc:description/>
  <dc:language>en-US</dc:language>
  <cp:lastModifiedBy>MD Rahman</cp:lastModifiedBy>
  <cp:lastPrinted>2017-11-09T02:01:15Z</cp:lastPrinted>
  <dcterms:modified xsi:type="dcterms:W3CDTF">2021-06-02T20:42:59Z</dcterms:modified>
  <cp:revision>6</cp:revision>
  <dc:subject/>
  <dc:title>Slide 1</dc:title>
</cp:coreProperties>
</file>